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04"/>
  </p:normalViewPr>
  <p:slideViewPr>
    <p:cSldViewPr snapToGrid="0" snapToObjects="1">
      <p:cViewPr>
        <p:scale>
          <a:sx n="92" d="100"/>
          <a:sy n="92" d="100"/>
        </p:scale>
        <p:origin x="-416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9B729-E391-6900-AF56-1A2294F085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EBE5BB-9041-E17B-5405-B8B2E393D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5DBA2-74EB-459A-7D6F-126BB0D67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5A8C1-CD9F-D41A-1522-984DB71C9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29257-4941-0BFE-4264-DDC9C91DB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DD8DB-A95D-9E8E-A3FA-42C7578C5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8765F-916E-150F-9F6C-D18E09CE7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4EA821-704C-1584-C87D-D591CA02C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8CA64-F7D4-F5C0-8C0F-0F0B439DA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27FEB-D173-28CA-B8FC-8B609BDC2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1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629463-96A5-6DD4-586B-48687A7FF9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CCE94-3675-080C-A434-359E321EA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F12D-0DF3-DF2C-16C1-8E6F74AFE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D9B32-1C7E-DA56-F437-B909E270E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BC8C7-8024-103A-BC3C-6BF22F6C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84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03F4D-0BE3-5601-6A4B-3060855B1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2700C-721D-69B9-C19B-CD879808C3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51298-D096-42FB-A84E-A3C71FF44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487C9-2577-0DAD-B7D1-F22C5642B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A7CE0-E953-DFBD-D950-FCBF0D4D0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58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B64C4-CF37-BAF8-F113-9137E3D73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4BC19-6E2E-DD2D-9AD7-976483EF32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1AEE02-B642-4C79-6963-5C988B663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FF17C3-0465-CA93-DE2F-74746380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9251A-2EDA-F996-9D5D-339F9C6F3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5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57251-94FC-8D9A-DAA0-2D612ED6C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0608-2687-9281-9F75-25A4F4DC4F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03EE7D-57C4-617C-FF62-F53FB406D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61054-41E6-7E1A-8368-4F1FD5768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10D4B-DBE6-78C0-8048-4A2D6E1C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9B6B21-DA08-3FFA-35DC-9FBEC09DF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4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28FC8-53E0-83DD-ACC1-6F402C801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695E07-97CA-EDF3-BCB6-4F069D10C2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14E29F-59D4-1513-8A1A-9F571F2EB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1DC11D-9861-F9AD-24AE-B532B7EF34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DA4811-6E5D-7ED9-EF26-064768552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C7335F-C079-62D0-B528-6E175278D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78C5EE-B4BF-677B-FC4E-7C56406CA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C7C55-FF6A-79C5-3668-8D0610E07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26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FA0A7-053F-BFED-2894-CA2EAA29E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A84D1-D947-4D2C-8EC2-EC315596D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B97AF1-919E-EEC9-4886-4EB6E79DF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9BD1C-2CE1-1172-B175-45B577225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607EC5-7167-5489-9999-B86C0E20A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25B6A2-9702-A93F-1A36-AB4DF9790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28E1F5-35DB-5D1A-83C7-F8E5D910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36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4EEA4-E8C3-7893-A078-5B628EC9E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0385D7-9AA9-5FD2-8E47-C67DEE773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BB218-3CEA-D41C-E1BD-2628188CE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D3D137-6D20-E5E1-6984-B3C4E3A1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C99AE-B37D-0200-DC43-89D4A87CD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57C3CD-B89E-16E3-ECA4-607C779F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56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FB05C-194B-F802-0EF6-8DE1FF005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E0FACB-3FCF-BEBE-5117-9F2645190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B2C426-F2BB-5470-029F-D0B3DB7D9E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A831F8-6223-4CA7-9E0C-7DCBD74C1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58A799-5A93-9351-8C7E-C3B3A21D9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8693E2-7E10-1916-8C49-168DA5CA6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75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8673D-C1B4-247E-0CE6-84A429092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C44769-77DD-5A60-13CA-CB791CFB5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20AD5-701C-8664-2A22-33C1DCC11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F3142-90F7-73CE-3F49-0702336567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9481B7-FE34-F2E1-E3FD-A5B8635DA0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3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93F16BEC-121F-39F3-A357-9DDB3E8EE2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98073" y="6407727"/>
            <a:ext cx="7786255" cy="450273"/>
          </a:xfrm>
        </p:spPr>
        <p:txBody>
          <a:bodyPr>
            <a:normAutofit/>
          </a:bodyPr>
          <a:lstStyle/>
          <a:p>
            <a:r>
              <a:rPr lang="en-US" sz="1200" b="1" dirty="0"/>
              <a:t>Figure S2. </a:t>
            </a:r>
            <a:r>
              <a:rPr lang="en-US" sz="1200" dirty="0"/>
              <a:t>BRIG comparison of IncHI1 plasmids carrying In110 </a:t>
            </a:r>
            <a:r>
              <a:rPr lang="en-US" sz="1200" dirty="0" err="1"/>
              <a:t>integrons</a:t>
            </a:r>
            <a:r>
              <a:rPr lang="en-US" sz="1200" dirty="0"/>
              <a:t> isolated in the Czech Republic.</a:t>
            </a:r>
          </a:p>
        </p:txBody>
      </p:sp>
      <p:pic>
        <p:nvPicPr>
          <p:cNvPr id="7" name="Picture 6" descr="Chart, sunburst chart&#10;&#10;Description automatically generated">
            <a:extLst>
              <a:ext uri="{FF2B5EF4-FFF2-40B4-BE49-F238E27FC236}">
                <a16:creationId xmlns:a16="http://schemas.microsoft.com/office/drawing/2014/main" id="{0D4D1128-4C4D-F629-78E6-37DC4408A2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000" y="173182"/>
            <a:ext cx="6303818" cy="63038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079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2</cp:revision>
  <dcterms:created xsi:type="dcterms:W3CDTF">2022-06-10T08:29:36Z</dcterms:created>
  <dcterms:modified xsi:type="dcterms:W3CDTF">2022-06-10T08:57:58Z</dcterms:modified>
</cp:coreProperties>
</file>